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325A63-3F48-4F3A-93EE-2A29347C88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4373F-CA6F-4A09-8454-764EB27630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52B33-1B36-4299-B506-FDFAF6E475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040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46720" y="264168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08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040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46720" y="6446160"/>
            <a:ext cx="187236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E1672-99B0-4271-B0CE-B8AD0B8F34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05C7B-CCEC-4659-A328-954F89AC48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DD171C-C143-4F57-8056-87E18D9100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D8DF56-1F69-482F-8962-39E15CD7AA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2CD25-FE87-4DA3-A4E2-B6BB387206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080" y="812520"/>
            <a:ext cx="5815080" cy="699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AB8BF-4718-44CF-9F68-A0F2BE9A23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F6F16-944B-4DB8-8413-37F552461D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493800" y="644616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6E031-8FA8-4258-B260-3A6EE974F4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08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493800" y="2641680"/>
            <a:ext cx="283752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080" y="6446160"/>
            <a:ext cx="5815080" cy="347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04158-028C-4F81-9756-9DD747D1F2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080" y="812520"/>
            <a:ext cx="5815080" cy="1509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080" y="2641680"/>
            <a:ext cx="5815080" cy="7283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31120"/>
            <a:ext cx="215748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31120"/>
            <a:ext cx="1414440" cy="595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defRPr>
            </a:lvl1pPr>
          </a:lstStyle>
          <a:p>
            <a:pPr indent="0"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17EAE169-972F-4CFD-8BF8-9FF2516D3FB7}" type="slidenum">
              <a:rPr b="0" lang="nl-NL" sz="2400" spc="-1" strike="noStrike">
                <a:solidFill>
                  <a:srgbClr val="000000"/>
                </a:solidFill>
                <a:latin typeface="Times New Roman"/>
                <a:ea typeface="Lucida Sans Unicode"/>
              </a:rPr>
              <a:t>&lt;number&gt;</a:t>
            </a:fld>
            <a:endParaRPr b="0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"/>
          <p:cNvSpPr/>
          <p:nvPr/>
        </p:nvSpPr>
        <p:spPr>
          <a:xfrm>
            <a:off x="0" y="8532720"/>
            <a:ext cx="685800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S9 Fig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Effects of changes in the GH/IGF1 axis on deiodinase activities. Activities of D3 (A) and D1 (B) in 6-month-old WT and bGH transgenic mice and of D3 (C) and D1 (D) in 2-month-old WT and </a:t>
            </a: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Ghr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Lucida Sans Unicode"/>
              </a:rPr>
              <a:t> KO mice. Values represent mean ± SE per group (n=5-6). * P &lt; 0.05; ** P &lt; 0.01 *** P &lt; 0.001. </a:t>
            </a:r>
            <a:endParaRPr b="0" lang="en-US" sz="11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Text Box 2"/>
          <p:cNvSpPr/>
          <p:nvPr/>
        </p:nvSpPr>
        <p:spPr>
          <a:xfrm>
            <a:off x="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A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Text Box 3"/>
          <p:cNvSpPr/>
          <p:nvPr/>
        </p:nvSpPr>
        <p:spPr>
          <a:xfrm>
            <a:off x="3429000" y="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B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Text Box 4"/>
          <p:cNvSpPr/>
          <p:nvPr/>
        </p:nvSpPr>
        <p:spPr>
          <a:xfrm>
            <a:off x="0" y="2563920"/>
            <a:ext cx="38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250"/>
              </a:spcBef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  <a:ea typeface="Lucida Sans Unicode"/>
              </a:rPr>
              <a:t>C</a:t>
            </a:r>
            <a:endParaRPr b="0" lang="en-US" sz="1800" spc="-1" strike="noStrike">
              <a:solidFill>
                <a:srgbClr val="ffffff"/>
              </a:solidFill>
              <a:latin typeface="Times New Roman"/>
            </a:endParaRPr>
          </a:p>
        </p:txBody>
      </p:sp>
      <p:grpSp>
        <p:nvGrpSpPr>
          <p:cNvPr id="45" name="Group 5"/>
          <p:cNvGrpSpPr/>
          <p:nvPr/>
        </p:nvGrpSpPr>
        <p:grpSpPr>
          <a:xfrm>
            <a:off x="1268280" y="2637000"/>
            <a:ext cx="1071720" cy="307080"/>
            <a:chOff x="1268280" y="2637000"/>
            <a:chExt cx="1071720" cy="307080"/>
          </a:xfrm>
        </p:grpSpPr>
        <p:sp>
          <p:nvSpPr>
            <p:cNvPr id="46" name="Text Box 6"/>
            <p:cNvSpPr/>
            <p:nvPr/>
          </p:nvSpPr>
          <p:spPr>
            <a:xfrm>
              <a:off x="1708200" y="2637000"/>
              <a:ext cx="496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47" name="Line 7"/>
            <p:cNvSpPr/>
            <p:nvPr/>
          </p:nvSpPr>
          <p:spPr>
            <a:xfrm>
              <a:off x="1268280" y="2847960"/>
              <a:ext cx="1071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grpSp>
        <p:nvGrpSpPr>
          <p:cNvPr id="48" name="Group 8"/>
          <p:cNvGrpSpPr/>
          <p:nvPr/>
        </p:nvGrpSpPr>
        <p:grpSpPr>
          <a:xfrm>
            <a:off x="1268280" y="108000"/>
            <a:ext cx="1071720" cy="307080"/>
            <a:chOff x="1268280" y="108000"/>
            <a:chExt cx="1071720" cy="307080"/>
          </a:xfrm>
        </p:grpSpPr>
        <p:sp>
          <p:nvSpPr>
            <p:cNvPr id="49" name="Text Box 9"/>
            <p:cNvSpPr/>
            <p:nvPr/>
          </p:nvSpPr>
          <p:spPr>
            <a:xfrm>
              <a:off x="1708200" y="108000"/>
              <a:ext cx="496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0" name="Line 10"/>
            <p:cNvSpPr/>
            <p:nvPr/>
          </p:nvSpPr>
          <p:spPr>
            <a:xfrm>
              <a:off x="1268280" y="318960"/>
              <a:ext cx="1071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grpSp>
        <p:nvGrpSpPr>
          <p:cNvPr id="51" name="Group 11"/>
          <p:cNvGrpSpPr/>
          <p:nvPr/>
        </p:nvGrpSpPr>
        <p:grpSpPr>
          <a:xfrm>
            <a:off x="5027760" y="20520"/>
            <a:ext cx="1071360" cy="307080"/>
            <a:chOff x="5027760" y="20520"/>
            <a:chExt cx="1071360" cy="307080"/>
          </a:xfrm>
        </p:grpSpPr>
        <p:sp>
          <p:nvSpPr>
            <p:cNvPr id="52" name="Text Box 12"/>
            <p:cNvSpPr/>
            <p:nvPr/>
          </p:nvSpPr>
          <p:spPr>
            <a:xfrm>
              <a:off x="5467320" y="20520"/>
              <a:ext cx="496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876"/>
                </a:spcBef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*</a:t>
              </a:r>
              <a:endParaRPr b="0" lang="en-US" sz="1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3" name="Line 13"/>
            <p:cNvSpPr/>
            <p:nvPr/>
          </p:nvSpPr>
          <p:spPr>
            <a:xfrm>
              <a:off x="5027760" y="231840"/>
              <a:ext cx="1071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  <p:pic>
        <p:nvPicPr>
          <p:cNvPr id="54" name="Picture 14" descr=""/>
          <p:cNvPicPr/>
          <p:nvPr/>
        </p:nvPicPr>
        <p:blipFill>
          <a:blip r:embed="rId1"/>
          <a:stretch/>
        </p:blipFill>
        <p:spPr>
          <a:xfrm>
            <a:off x="0" y="0"/>
            <a:ext cx="3057480" cy="26002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5" descr=""/>
          <p:cNvPicPr/>
          <p:nvPr/>
        </p:nvPicPr>
        <p:blipFill>
          <a:blip r:embed="rId2"/>
          <a:stretch/>
        </p:blipFill>
        <p:spPr>
          <a:xfrm>
            <a:off x="3800520" y="0"/>
            <a:ext cx="3057480" cy="260028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6" descr=""/>
          <p:cNvPicPr/>
          <p:nvPr/>
        </p:nvPicPr>
        <p:blipFill>
          <a:blip r:embed="rId3"/>
          <a:stretch/>
        </p:blipFill>
        <p:spPr>
          <a:xfrm>
            <a:off x="0" y="2556000"/>
            <a:ext cx="3057480" cy="260028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9T09:26:31Z</dcterms:created>
  <dc:creator>USER</dc:creator>
  <dc:description/>
  <dc:language>en-US</dc:language>
  <cp:lastModifiedBy>Edward Visser</cp:lastModifiedBy>
  <dcterms:modified xsi:type="dcterms:W3CDTF">2016-02-11T12:46:51Z</dcterms:modified>
  <cp:revision>111</cp:revision>
  <dc:subject/>
  <dc:title>PowerPoint Presentation</dc:title>
</cp:coreProperties>
</file>